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AD8726D5-C824-FB4B-AA54-2F3B1B023A4D}" v="2" dt="2023-03-09T15:56:40.568"/>
  </p1510:revLst>
</p1510:revInfo>
</file>

<file path=ppt/tableStyles.xml><?xml version="1.0" encoding="utf-8"?>
<a:tblStyleLst xmlns:a="http://schemas.openxmlformats.org/drawingml/2006/main" def="{5C22544A-7EE6-4342-B048-85BDC9FD1C3A}"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6E25E649-3F16-4E02-A733-19D2CDBF48F0}" styleName="Medium Style 3 - Accent 1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D7AC3CCA-C797-4891-BE02-D94E43425B78}" styleName="Medium Style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  <a:tblStyle styleId="{5202B0CA-FC54-4496-8BCA-5EF66A818D29}" styleName="Dark Style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1"/>
    <p:restoredTop sz="96327"/>
  </p:normalViewPr>
  <p:slideViewPr>
    <p:cSldViewPr snapToGrid="0">
      <p:cViewPr varScale="1">
        <p:scale>
          <a:sx n="128" d="100"/>
          <a:sy n="128" d="100"/>
        </p:scale>
        <p:origin x="480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16FA190-CF78-BB03-C93B-45988567A54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8DBBBDF-9E5C-3660-3899-09C3C8DFF34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EA82F34-2B8E-704F-4014-ECF8410930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05664C-AB7E-E941-864D-C9AE69E1AF51}" type="datetimeFigureOut">
              <a:rPr lang="en-US" smtClean="0"/>
              <a:t>3/8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61FFC80-A1AC-20AD-9B22-B68C2AD1A5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32C0748-22E8-6194-D208-AD73D77BF3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DB176F-D032-894C-947F-23F8AC3E37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40383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3668A8D-8110-766D-B0AF-107B9C0441E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FDF03AC-CA85-B289-6547-9BFF2EBBC9D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2613B47-4DAE-5A5A-9F47-6AFD00E9EF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05664C-AB7E-E941-864D-C9AE69E1AF51}" type="datetimeFigureOut">
              <a:rPr lang="en-US" smtClean="0"/>
              <a:t>3/8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C57242D-4E4B-8EFB-98EF-78FEBF85F7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94B86E0-0B4A-F494-F421-FBC874AEC6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DB176F-D032-894C-947F-23F8AC3E37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00205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E372108-CC92-C2F1-C832-48FD6EE9748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A3C4184-8E8A-82E9-DB7A-8240335EDDE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10B65BA-FBB5-80EE-3E70-0BE0806FCF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05664C-AB7E-E941-864D-C9AE69E1AF51}" type="datetimeFigureOut">
              <a:rPr lang="en-US" smtClean="0"/>
              <a:t>3/8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21E4894-8F46-CA92-EA6C-C1774A99D8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0908ED2-E0C6-FAB7-8BD1-6587C6DAB9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DB176F-D032-894C-947F-23F8AC3E37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39399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86F8CF-63D3-3AB6-4347-E5BF9EC1630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5971B1B-9918-FD9C-1080-55369528047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55ADE64-471C-7940-F08A-3F62272FA9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05664C-AB7E-E941-864D-C9AE69E1AF51}" type="datetimeFigureOut">
              <a:rPr lang="en-US" smtClean="0"/>
              <a:t>3/8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FF565B1-8F64-FD10-9012-B7D703989F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32F884C-08DB-D8C0-F76D-05C174551E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DB176F-D032-894C-947F-23F8AC3E37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96715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8E676F1-BA4D-E18B-B63E-252753D1C02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6F06CC4-937A-976F-FBEF-8745C24D893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3AB6F3D-E41D-5BE6-3751-99D99E2D75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05664C-AB7E-E941-864D-C9AE69E1AF51}" type="datetimeFigureOut">
              <a:rPr lang="en-US" smtClean="0"/>
              <a:t>3/8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4A37ACE-FC46-A6F7-E1BD-482EF86037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4FE1CB0-658B-ADFE-1B03-68D36B20C6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DB176F-D032-894C-947F-23F8AC3E37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14061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6616A7F-F659-BD29-17EE-F5C2687C7CF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8341C66-CDA8-E4E7-3875-53453DDAE36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F970794-1411-26F0-4558-060DB8D3807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7E2854E-D397-98EC-0EAC-F3F547DAB8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05664C-AB7E-E941-864D-C9AE69E1AF51}" type="datetimeFigureOut">
              <a:rPr lang="en-US" smtClean="0"/>
              <a:t>3/8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5688B1A-DF53-5F84-DFAC-A3BCEEF1A3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C3AD783-1300-8AA9-6475-CFB0B9B035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DB176F-D032-894C-947F-23F8AC3E37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4306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E814D84-471C-CEB7-B212-7404E0B560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E2E3D50-AEC3-F683-7441-1FAE825C061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EDAB1BB-2E67-5FC1-509B-95FF066FE27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C45F9FC-7854-A35B-66BE-2CC282221FF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04EE8F1-555B-FB5B-0BB0-1FF86A65464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CDC4D94-4C2C-1EA4-792A-0AB90CD4D6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05664C-AB7E-E941-864D-C9AE69E1AF51}" type="datetimeFigureOut">
              <a:rPr lang="en-US" smtClean="0"/>
              <a:t>3/8/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C99FB73-C103-F5F8-9F8F-FDE733202A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8766F78-A021-BC29-400C-7E1742FB35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DB176F-D032-894C-947F-23F8AC3E37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16157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FA1E962-06F5-2A1C-6017-57D351E34FD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9BA1613-FB21-35EF-AB74-21CC297CAF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05664C-AB7E-E941-864D-C9AE69E1AF51}" type="datetimeFigureOut">
              <a:rPr lang="en-US" smtClean="0"/>
              <a:t>3/8/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BC54053-A60D-8C3E-2C31-2402A48D4D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AFAF26C-A87C-500A-42CD-6785E3B5B9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DB176F-D032-894C-947F-23F8AC3E37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92951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F34E4FC-34BB-5B91-3872-13A140B36B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05664C-AB7E-E941-864D-C9AE69E1AF51}" type="datetimeFigureOut">
              <a:rPr lang="en-US" smtClean="0"/>
              <a:t>3/8/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C70B48F-BF4F-B67B-9928-934C2C972F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5AC55C5-CA45-7AA3-5D24-A9AF5EFE9C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DB176F-D032-894C-947F-23F8AC3E37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56728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EC1B16D-D50B-ACE2-B26D-8F69609BF6F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2C907B5-DB5C-8F87-6BB3-F52DCEE872C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59E55EB-A72F-E2C6-529D-B68471F6364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1AEEB83-20EC-E67E-0EDF-3A80925065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05664C-AB7E-E941-864D-C9AE69E1AF51}" type="datetimeFigureOut">
              <a:rPr lang="en-US" smtClean="0"/>
              <a:t>3/8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1F534A4-91B9-512D-8852-693B01F7D2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B8F94A1-AA91-EBC8-1DAB-A3E0319666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DB176F-D032-894C-947F-23F8AC3E37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3510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B800DC2-3C49-E998-1A21-B0F0EDF802E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E2FB805-B8F9-033B-57A6-0DCF43E0E8B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D095AB8-38C9-1631-EE75-25A1ACB2628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2376250-10F7-B5A9-0659-D2792A1082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05664C-AB7E-E941-864D-C9AE69E1AF51}" type="datetimeFigureOut">
              <a:rPr lang="en-US" smtClean="0"/>
              <a:t>3/8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31153E6-5C9C-D340-BB47-ACD67CC277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A4BE8DB-ACFC-C449-10B0-CF00A7A5F4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DB176F-D032-894C-947F-23F8AC3E37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71196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C902899-7297-1B39-5D33-ACB31C139E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6929050-9134-CDC6-8294-00798CD4842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236BBBC-70A3-3B4A-2719-400A06F74C2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05664C-AB7E-E941-864D-C9AE69E1AF51}" type="datetimeFigureOut">
              <a:rPr lang="en-US" smtClean="0"/>
              <a:t>3/8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1EC1242-1B49-7EB1-17D0-272CA3120B9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746558F-E22A-E80A-8B32-8D92988B31D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DB176F-D032-894C-947F-23F8AC3E37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28791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Table 6">
            <a:extLst>
              <a:ext uri="{FF2B5EF4-FFF2-40B4-BE49-F238E27FC236}">
                <a16:creationId xmlns:a16="http://schemas.microsoft.com/office/drawing/2014/main" id="{370447EC-528C-B75D-F26C-6F03DAEAE03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98323281"/>
              </p:ext>
            </p:extLst>
          </p:nvPr>
        </p:nvGraphicFramePr>
        <p:xfrm>
          <a:off x="1130852" y="3535569"/>
          <a:ext cx="5537200" cy="1295400"/>
        </p:xfrm>
        <a:graphic>
          <a:graphicData uri="http://schemas.openxmlformats.org/drawingml/2006/table">
            <a:tbl>
              <a:tblPr>
                <a:tableStyleId>{5940675A-B579-460E-94D1-54222C63F5DA}</a:tableStyleId>
              </a:tblPr>
              <a:tblGrid>
                <a:gridCol w="1381923">
                  <a:extLst>
                    <a:ext uri="{9D8B030D-6E8A-4147-A177-3AD203B41FA5}">
                      <a16:colId xmlns:a16="http://schemas.microsoft.com/office/drawing/2014/main" val="3693497135"/>
                    </a:ext>
                  </a:extLst>
                </a:gridCol>
                <a:gridCol w="1103003">
                  <a:extLst>
                    <a:ext uri="{9D8B030D-6E8A-4147-A177-3AD203B41FA5}">
                      <a16:colId xmlns:a16="http://schemas.microsoft.com/office/drawing/2014/main" val="179195004"/>
                    </a:ext>
                  </a:extLst>
                </a:gridCol>
                <a:gridCol w="979390">
                  <a:extLst>
                    <a:ext uri="{9D8B030D-6E8A-4147-A177-3AD203B41FA5}">
                      <a16:colId xmlns:a16="http://schemas.microsoft.com/office/drawing/2014/main" val="2436130305"/>
                    </a:ext>
                  </a:extLst>
                </a:gridCol>
                <a:gridCol w="827252">
                  <a:extLst>
                    <a:ext uri="{9D8B030D-6E8A-4147-A177-3AD203B41FA5}">
                      <a16:colId xmlns:a16="http://schemas.microsoft.com/office/drawing/2014/main" val="962883385"/>
                    </a:ext>
                  </a:extLst>
                </a:gridCol>
                <a:gridCol w="1245632">
                  <a:extLst>
                    <a:ext uri="{9D8B030D-6E8A-4147-A177-3AD203B41FA5}">
                      <a16:colId xmlns:a16="http://schemas.microsoft.com/office/drawing/2014/main" val="2604295983"/>
                    </a:ext>
                  </a:extLst>
                </a:gridCol>
              </a:tblGrid>
              <a:tr h="431800">
                <a:tc>
                  <a:txBody>
                    <a:bodyPr/>
                    <a:lstStyle/>
                    <a:p>
                      <a:pPr algn="ctr" fontAlgn="t"/>
                      <a:r>
                        <a:rPr lang="en-US" sz="1200" b="1" u="none" strike="noStrike" dirty="0" err="1">
                          <a:solidFill>
                            <a:srgbClr val="000000"/>
                          </a:solidFill>
                          <a:effectLst/>
                        </a:rPr>
                        <a:t>rsID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200" b="1" u="none" strike="noStrike">
                          <a:solidFill>
                            <a:srgbClr val="000000"/>
                          </a:solidFill>
                          <a:effectLst/>
                        </a:rPr>
                        <a:t>Variant Name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200" b="1" u="none" strike="noStrike">
                          <a:solidFill>
                            <a:srgbClr val="000000"/>
                          </a:solidFill>
                          <a:effectLst/>
                        </a:rPr>
                        <a:t>Legacy Name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200" b="1" u="none" strike="noStrike">
                          <a:solidFill>
                            <a:srgbClr val="000000"/>
                          </a:solidFill>
                          <a:effectLst/>
                        </a:rPr>
                        <a:t>Allele Age (years)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200" b="1" u="none" strike="noStrike" dirty="0">
                          <a:solidFill>
                            <a:srgbClr val="000000"/>
                          </a:solidFill>
                          <a:effectLst/>
                        </a:rPr>
                        <a:t>Time (Generations)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9525" marR="9525" marT="9525" marB="0"/>
                </a:tc>
                <a:extLst>
                  <a:ext uri="{0D108BD9-81ED-4DB2-BD59-A6C34878D82A}">
                    <a16:rowId xmlns:a16="http://schemas.microsoft.com/office/drawing/2014/main" val="742904093"/>
                  </a:ext>
                </a:extLst>
              </a:tr>
              <a:tr h="215900"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rs13972999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c.3468G&gt;A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3600G&gt;A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670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27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9525" marR="9525" marT="9525" marB="0"/>
                </a:tc>
                <a:extLst>
                  <a:ext uri="{0D108BD9-81ED-4DB2-BD59-A6C34878D82A}">
                    <a16:rowId xmlns:a16="http://schemas.microsoft.com/office/drawing/2014/main" val="2523032802"/>
                  </a:ext>
                </a:extLst>
              </a:tr>
              <a:tr h="215900"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rs19392250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c.1367T&gt;C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V456A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530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21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9525" marR="9525" marT="9525" marB="0"/>
                </a:tc>
                <a:extLst>
                  <a:ext uri="{0D108BD9-81ED-4DB2-BD59-A6C34878D82A}">
                    <a16:rowId xmlns:a16="http://schemas.microsoft.com/office/drawing/2014/main" val="781493230"/>
                  </a:ext>
                </a:extLst>
              </a:tr>
              <a:tr h="215900"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rs7671377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c.1585-1G&gt;A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1717-1G-&gt;A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10,60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42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9525" marR="9525" marT="9525" marB="0"/>
                </a:tc>
                <a:extLst>
                  <a:ext uri="{0D108BD9-81ED-4DB2-BD59-A6C34878D82A}">
                    <a16:rowId xmlns:a16="http://schemas.microsoft.com/office/drawing/2014/main" val="452654572"/>
                  </a:ext>
                </a:extLst>
              </a:tr>
              <a:tr h="215900"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rs7764690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c.1558G&gt;T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V520F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</a:rPr>
                        <a:t>850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338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9525" marR="9525" marT="9525" marB="0"/>
                </a:tc>
                <a:extLst>
                  <a:ext uri="{0D108BD9-81ED-4DB2-BD59-A6C34878D82A}">
                    <a16:rowId xmlns:a16="http://schemas.microsoft.com/office/drawing/2014/main" val="2727045290"/>
                  </a:ext>
                </a:extLst>
              </a:tr>
            </a:tbl>
          </a:graphicData>
        </a:graphic>
      </p:graphicFrame>
      <p:pic>
        <p:nvPicPr>
          <p:cNvPr id="10" name="Picture 4">
            <a:extLst>
              <a:ext uri="{FF2B5EF4-FFF2-40B4-BE49-F238E27FC236}">
                <a16:creationId xmlns:a16="http://schemas.microsoft.com/office/drawing/2014/main" id="{913610D9-FF5B-92A9-1D01-65FEDAEA979B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4626"/>
          <a:stretch/>
        </p:blipFill>
        <p:spPr bwMode="auto">
          <a:xfrm>
            <a:off x="1921567" y="592758"/>
            <a:ext cx="3810000" cy="271062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11" name="Straight Arrow Connector 10">
            <a:extLst>
              <a:ext uri="{FF2B5EF4-FFF2-40B4-BE49-F238E27FC236}">
                <a16:creationId xmlns:a16="http://schemas.microsoft.com/office/drawing/2014/main" id="{2B4B6145-E17D-17C7-A1FC-55C30FEC924E}"/>
              </a:ext>
            </a:extLst>
          </p:cNvPr>
          <p:cNvCxnSpPr/>
          <p:nvPr/>
        </p:nvCxnSpPr>
        <p:spPr>
          <a:xfrm>
            <a:off x="3826567" y="2452204"/>
            <a:ext cx="0" cy="1003852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3"/>
          </a:lnRef>
          <a:fillRef idx="0">
            <a:schemeClr val="accent3"/>
          </a:fillRef>
          <a:effectRef idx="2">
            <a:schemeClr val="accent3"/>
          </a:effectRef>
          <a:fontRef idx="minor">
            <a:schemeClr val="tx1"/>
          </a:fontRef>
        </p:style>
      </p:cxnSp>
      <p:sp>
        <p:nvSpPr>
          <p:cNvPr id="13" name="TextBox 12">
            <a:extLst>
              <a:ext uri="{FF2B5EF4-FFF2-40B4-BE49-F238E27FC236}">
                <a16:creationId xmlns:a16="http://schemas.microsoft.com/office/drawing/2014/main" id="{EA585F55-BCF0-AB10-6D85-1B48FA1E7FA6}"/>
              </a:ext>
            </a:extLst>
          </p:cNvPr>
          <p:cNvSpPr txBox="1"/>
          <p:nvPr/>
        </p:nvSpPr>
        <p:spPr>
          <a:xfrm>
            <a:off x="1049407" y="5401365"/>
            <a:ext cx="6593784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/>
              <a:t>Supplementary Figure 1</a:t>
            </a:r>
            <a:r>
              <a:rPr lang="en-US" sz="1200" dirty="0"/>
              <a:t>. Venn diagram showing genealogical estimation of variant age (GEVA) analysis of CF-causing variants. Age estimates of four CF-causing variants dated in GEVA are shown. 1717-1G&gt;A was the oldest among all four reported while V456A was the youngest.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7D296B96-E2AD-5C29-1EEC-EF962668BD99}"/>
              </a:ext>
            </a:extLst>
          </p:cNvPr>
          <p:cNvSpPr txBox="1"/>
          <p:nvPr/>
        </p:nvSpPr>
        <p:spPr>
          <a:xfrm>
            <a:off x="1428219" y="360569"/>
            <a:ext cx="160922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CF-causing variants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223E338F-A06E-4E67-0282-78944A3F5D66}"/>
              </a:ext>
            </a:extLst>
          </p:cNvPr>
          <p:cNvSpPr txBox="1"/>
          <p:nvPr/>
        </p:nvSpPr>
        <p:spPr>
          <a:xfrm>
            <a:off x="4585740" y="360569"/>
            <a:ext cx="22780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Dated variants in </a:t>
            </a:r>
            <a:r>
              <a:rPr lang="en-US" sz="1400" b="1" i="1" dirty="0"/>
              <a:t>CFTR</a:t>
            </a:r>
            <a:r>
              <a:rPr lang="en-US" sz="1400" b="1" dirty="0"/>
              <a:t> locus</a:t>
            </a:r>
          </a:p>
        </p:txBody>
      </p:sp>
    </p:spTree>
    <p:extLst>
      <p:ext uri="{BB962C8B-B14F-4D97-AF65-F5344CB8AC3E}">
        <p14:creationId xmlns:p14="http://schemas.microsoft.com/office/powerpoint/2010/main" val="40019102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71</TotalTime>
  <Words>109</Words>
  <Application>Microsoft Macintosh PowerPoint</Application>
  <PresentationFormat>Widescreen</PresentationFormat>
  <Paragraphs>2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Helvetica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Ideozu, Justin E</dc:creator>
  <cp:lastModifiedBy>Ideozu, Justin E</cp:lastModifiedBy>
  <cp:revision>1</cp:revision>
  <dcterms:created xsi:type="dcterms:W3CDTF">2023-03-08T18:58:49Z</dcterms:created>
  <dcterms:modified xsi:type="dcterms:W3CDTF">2023-03-09T17:50:48Z</dcterms:modified>
</cp:coreProperties>
</file>